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8"/>
    <p:restoredTop sz="94641"/>
  </p:normalViewPr>
  <p:slideViewPr>
    <p:cSldViewPr snapToGrid="0" snapToObjects="1">
      <p:cViewPr varScale="1">
        <p:scale>
          <a:sx n="128" d="100"/>
          <a:sy n="128" d="100"/>
        </p:scale>
        <p:origin x="3256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320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902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97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327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386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696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279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40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67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1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130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2A592-4237-544F-8AFC-4833619CBC4C}" type="datetimeFigureOut">
              <a:rPr lang="en-US" smtClean="0"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B703F6-02D5-9245-AB4A-99A48D246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91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4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9.tiff"/><Relationship Id="rId5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4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5262" y="55811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4A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3" name="Picture 2" descr="4A 24 iNOS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82288" y="832808"/>
            <a:ext cx="1854708" cy="1915668"/>
          </a:xfrm>
          <a:prstGeom prst="rect">
            <a:avLst/>
          </a:prstGeom>
        </p:spPr>
      </p:pic>
      <p:pic>
        <p:nvPicPr>
          <p:cNvPr id="4" name="Picture 3" descr="4A 24 STAT3.tif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17372" y="3518072"/>
            <a:ext cx="1854708" cy="1915668"/>
          </a:xfrm>
          <a:prstGeom prst="rect">
            <a:avLst/>
          </a:prstGeom>
        </p:spPr>
      </p:pic>
      <p:pic>
        <p:nvPicPr>
          <p:cNvPr id="5" name="Picture 4" descr="4A 24 Tubulin.ti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90659" y="6134984"/>
            <a:ext cx="1854708" cy="191566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003765" y="1039835"/>
            <a:ext cx="613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iNOS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22415" y="6633596"/>
            <a:ext cx="9869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583235" y="1031723"/>
            <a:ext cx="1853761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837314" y="3892592"/>
            <a:ext cx="8039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590659" y="6617373"/>
            <a:ext cx="1854708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2629945" y="3861390"/>
            <a:ext cx="1833985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4397697" y="1058868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3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431082" y="6633596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967657" y="4457363"/>
            <a:ext cx="142244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Non-specific bands from STAT3 antibody</a:t>
            </a:r>
            <a:endParaRPr lang="en-US" sz="1100" dirty="0">
              <a:latin typeface="Arial"/>
              <a:cs typeface="Arial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4476260" y="4705259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triangle" w="lg" len="med"/>
            <a:tailEnd type="non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476260" y="3890844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4476260" y="4941467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triangle" w="lg" len="med"/>
            <a:tailEnd type="non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4476260" y="4227138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triangle" w="lg" len="med"/>
            <a:tailEnd type="non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Right Brace 29"/>
          <p:cNvSpPr/>
          <p:nvPr/>
        </p:nvSpPr>
        <p:spPr>
          <a:xfrm>
            <a:off x="4819992" y="4185391"/>
            <a:ext cx="102973" cy="974831"/>
          </a:xfrm>
          <a:prstGeom prst="rightBrac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4476260" y="3636708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triangle" w="lg" len="med"/>
            <a:tailEnd type="non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381485" y="555809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724250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4D sh-STAT3 STAT3 2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7734" y="3606604"/>
            <a:ext cx="1440000" cy="2117744"/>
          </a:xfrm>
          <a:prstGeom prst="rect">
            <a:avLst/>
          </a:prstGeom>
        </p:spPr>
      </p:pic>
      <p:pic>
        <p:nvPicPr>
          <p:cNvPr id="5" name="Picture 4" descr="4D sh-STAT3 Tubulin.tif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6879" y="6289933"/>
            <a:ext cx="1429512" cy="187756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98217" y="531380"/>
            <a:ext cx="890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4D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3" name="Picture 2" descr="4D sh-STAT3 iNOS.ti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3069" y="963883"/>
            <a:ext cx="1437132" cy="198577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44360" y="1438843"/>
            <a:ext cx="613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iNOS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23167" y="7436227"/>
            <a:ext cx="9869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713070" y="1430731"/>
            <a:ext cx="1437131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1712533" y="4351949"/>
            <a:ext cx="9869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13069" y="7420004"/>
            <a:ext cx="1437132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2707172" y="4343837"/>
            <a:ext cx="1448926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4127419" y="1457876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3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127419" y="743622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228158" y="5195170"/>
            <a:ext cx="13138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smtClean="0">
                <a:latin typeface="Arial"/>
                <a:cs typeface="Arial"/>
              </a:rPr>
              <a:t>Non-specific band</a:t>
            </a:r>
            <a:endParaRPr lang="en-US" sz="1100" dirty="0">
              <a:latin typeface="Arial"/>
              <a:cs typeface="Arial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2488496" y="5320771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triangle" w="lg" len="med"/>
            <a:tailEnd type="non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166329" y="7880658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HuR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127419" y="4373291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9" name="Rectangle 28"/>
          <p:cNvSpPr/>
          <p:nvPr/>
        </p:nvSpPr>
        <p:spPr>
          <a:xfrm>
            <a:off x="2699192" y="7849999"/>
            <a:ext cx="1447200" cy="317502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4127419" y="784999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2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034375" y="686884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8394740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4E 65 Mutant 1 STAT3.tif"/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87563" y="5739298"/>
            <a:ext cx="2350271" cy="1799844"/>
          </a:xfrm>
          <a:prstGeom prst="rect">
            <a:avLst/>
          </a:prstGeom>
        </p:spPr>
      </p:pic>
      <p:pic>
        <p:nvPicPr>
          <p:cNvPr id="2" name="Picture 1" descr="4E 65 Mutant 1 3 Tubulin.tif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12046" y="5797009"/>
            <a:ext cx="2364344" cy="1737895"/>
          </a:xfrm>
          <a:prstGeom prst="rect">
            <a:avLst/>
          </a:prstGeom>
        </p:spPr>
      </p:pic>
      <p:pic>
        <p:nvPicPr>
          <p:cNvPr id="3" name="Picture 2" descr="4E 65 Mutant 1 iNOS.tif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97690" y="1130758"/>
            <a:ext cx="2451396" cy="157123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318414" y="6192480"/>
            <a:ext cx="640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STAT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215650" y="6187357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8" name="Rectangle 7"/>
          <p:cNvSpPr/>
          <p:nvPr/>
        </p:nvSpPr>
        <p:spPr>
          <a:xfrm>
            <a:off x="812048" y="6374752"/>
            <a:ext cx="1558142" cy="303903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2197690" y="1510614"/>
            <a:ext cx="1529908" cy="324000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827568" y="1510614"/>
            <a:ext cx="821517" cy="324000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-70272" y="6349330"/>
            <a:ext cx="8823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r>
              <a:rPr lang="en-US" sz="1200" dirty="0" smtClean="0">
                <a:latin typeface="Arial"/>
                <a:cs typeface="Arial"/>
              </a:rPr>
              <a:t>-Tubulin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4183" y="6801068"/>
            <a:ext cx="777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 smtClean="0">
                <a:latin typeface="Arial"/>
                <a:cs typeface="Arial"/>
              </a:rPr>
              <a:t>HuR</a:t>
            </a:r>
            <a:endParaRPr lang="en-US" sz="1200" dirty="0" smtClean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589270" y="1510614"/>
            <a:ext cx="6068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 smtClean="0">
                <a:latin typeface="Arial"/>
                <a:cs typeface="Arial"/>
              </a:rPr>
              <a:t>iNO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98217" y="531380"/>
            <a:ext cx="877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4E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16" name="Picture 15" descr="4E 65 pY-STAT3.tif"/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"/>
          <a:stretch/>
        </p:blipFill>
        <p:spPr>
          <a:xfrm>
            <a:off x="2195540" y="3182905"/>
            <a:ext cx="2451396" cy="1798132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373131" y="3582599"/>
            <a:ext cx="866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pY-STAT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195541" y="3508009"/>
            <a:ext cx="1576103" cy="416802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4647071" y="3546537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675489" y="1555235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3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3887563" y="3508009"/>
            <a:ext cx="759372" cy="416802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1315371" y="1903540"/>
            <a:ext cx="880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pS-STAT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125256" y="6374753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37" name="Rectangle 36"/>
          <p:cNvSpPr/>
          <p:nvPr/>
        </p:nvSpPr>
        <p:spPr>
          <a:xfrm>
            <a:off x="806934" y="6817100"/>
            <a:ext cx="1563255" cy="281586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3125256" y="6822646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2</a:t>
            </a:r>
          </a:p>
        </p:txBody>
      </p:sp>
      <p:sp>
        <p:nvSpPr>
          <p:cNvPr id="39" name="Rectangle 38"/>
          <p:cNvSpPr/>
          <p:nvPr/>
        </p:nvSpPr>
        <p:spPr>
          <a:xfrm>
            <a:off x="2370189" y="6374752"/>
            <a:ext cx="806201" cy="303903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3887563" y="6156994"/>
            <a:ext cx="1580326" cy="324000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5467889" y="6156994"/>
            <a:ext cx="769946" cy="324000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2370189" y="6815957"/>
            <a:ext cx="806201" cy="281586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4553813" y="900712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0035882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4F iNOS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75815" y="3629482"/>
            <a:ext cx="1234440" cy="159905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06562" y="628897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</a:t>
            </a:r>
            <a:r>
              <a:rPr lang="en-US" b="1" dirty="0" smtClean="0">
                <a:latin typeface="Arial"/>
                <a:cs typeface="Arial"/>
              </a:rPr>
              <a:t>4G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4" name="Picture 3" descr="4F pY-STAT3.tif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75815" y="1263273"/>
            <a:ext cx="1264920" cy="1599057"/>
          </a:xfrm>
          <a:prstGeom prst="rect">
            <a:avLst/>
          </a:prstGeom>
        </p:spPr>
      </p:pic>
      <p:pic>
        <p:nvPicPr>
          <p:cNvPr id="5" name="Picture 4" descr="4F total STAT3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75815" y="6006550"/>
            <a:ext cx="1234440" cy="1599057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310966" y="3833286"/>
            <a:ext cx="613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iNOS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876022" y="3833285"/>
            <a:ext cx="1240427" cy="29238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4126303" y="3848675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3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153193" y="6529175"/>
            <a:ext cx="71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856270" y="6529175"/>
            <a:ext cx="1253985" cy="307777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4116449" y="6529175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2" name="Rectangle 21"/>
          <p:cNvSpPr/>
          <p:nvPr/>
        </p:nvSpPr>
        <p:spPr>
          <a:xfrm>
            <a:off x="2866502" y="4559083"/>
            <a:ext cx="1249947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1735182" y="4567195"/>
            <a:ext cx="1186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182751" y="458258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683856" y="6936391"/>
            <a:ext cx="1186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863635" y="1762140"/>
            <a:ext cx="97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Y-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856270" y="1735403"/>
            <a:ext cx="1296833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4217357" y="1762140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256286" y="6195262"/>
            <a:ext cx="613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iNOS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050694" y="986274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727308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</Words>
  <Application>Microsoft Macintosh PowerPoint</Application>
  <PresentationFormat>Letter Paper (8.5x11 in)</PresentationFormat>
  <Paragraphs>4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Ma</dc:creator>
  <cp:lastModifiedBy>Imed Gallouzi, Dr.</cp:lastModifiedBy>
  <cp:revision>2</cp:revision>
  <dcterms:created xsi:type="dcterms:W3CDTF">2017-02-06T17:05:23Z</dcterms:created>
  <dcterms:modified xsi:type="dcterms:W3CDTF">2017-02-06T18:35:12Z</dcterms:modified>
</cp:coreProperties>
</file>